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8" r:id="rId2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FF696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908" autoAdjust="0"/>
    <p:restoredTop sz="94660"/>
  </p:normalViewPr>
  <p:slideViewPr>
    <p:cSldViewPr>
      <p:cViewPr>
        <p:scale>
          <a:sx n="70" d="100"/>
          <a:sy n="70" d="100"/>
        </p:scale>
        <p:origin x="-1974" y="-54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40F7370-8137-48A9-9B36-93FD255E562B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6E7F467-1671-4A64-B470-828B4B2B14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158974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21117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484932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84552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368592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707623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304893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971558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025776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542997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617793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511119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26286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5261203" y="0"/>
            <a:ext cx="15967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</a:t>
            </a:r>
            <a:r>
              <a: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file </a:t>
            </a:r>
            <a:r>
              <a:rPr lang="en-US" altLang="ko-KR" sz="14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endParaRPr lang="en-US" altLang="ko-KR" sz="14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8" name="표 1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71053840"/>
              </p:ext>
            </p:extLst>
          </p:nvPr>
        </p:nvGraphicFramePr>
        <p:xfrm>
          <a:off x="5305732" y="1466153"/>
          <a:ext cx="1219612" cy="7621188"/>
        </p:xfrm>
        <a:graphic>
          <a:graphicData uri="http://schemas.openxmlformats.org/drawingml/2006/table">
            <a:tbl>
              <a:tblPr/>
              <a:tblGrid>
                <a:gridCol w="1219612"/>
              </a:tblGrid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A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A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A3 Isoform X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A3 Isoform X2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A1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B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00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B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00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B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00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B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00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B1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00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1 Isoform X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1 Isoform X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1 Isoform X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1 Isoform X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1 Isoform X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1 Isoform X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1 Isoform X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1 Isoform X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1 Isoform X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1 Isoform X1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2 Isoform X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2 Isoform X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-lik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D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D4 Isoform X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D4 Isoform X2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E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B05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F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F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F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G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B0F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G_12505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B0F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G_9050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B0F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G_7515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B0F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G_10530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B0F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G5 Isoform X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B0F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G5 Isoform X2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B0F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H_13928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030A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H_8870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030A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H_10300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030A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H_5558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030A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H_6864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030A0"/>
                    </a:solidFill>
                  </a:tcPr>
                </a:tc>
              </a:tr>
            </a:tbl>
          </a:graphicData>
        </a:graphic>
      </p:graphicFrame>
      <p:pic>
        <p:nvPicPr>
          <p:cNvPr id="19" name="Picture 2"/>
          <p:cNvPicPr preferRelativeResize="0">
            <a:picLocks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98255"/>
          <a:stretch/>
        </p:blipFill>
        <p:spPr bwMode="auto">
          <a:xfrm>
            <a:off x="965165" y="118550"/>
            <a:ext cx="1378056" cy="785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0" name="TextBox 19"/>
          <p:cNvSpPr txBox="1"/>
          <p:nvPr/>
        </p:nvSpPr>
        <p:spPr>
          <a:xfrm>
            <a:off x="888823" y="173077"/>
            <a:ext cx="3600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</a:t>
            </a:r>
            <a:endParaRPr lang="ko-KR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2111289" y="173077"/>
            <a:ext cx="3513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0</a:t>
            </a:r>
            <a:endParaRPr lang="ko-KR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4" name="표 2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90977769"/>
              </p:ext>
            </p:extLst>
          </p:nvPr>
        </p:nvGraphicFramePr>
        <p:xfrm>
          <a:off x="5305732" y="1466153"/>
          <a:ext cx="1189038" cy="7621188"/>
        </p:xfrm>
        <a:graphic>
          <a:graphicData uri="http://schemas.openxmlformats.org/drawingml/2006/table">
            <a:tbl>
              <a:tblPr/>
              <a:tblGrid>
                <a:gridCol w="1189038"/>
              </a:tblGrid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A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A3 isoform X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A3 isoform X2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A5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A1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B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00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B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00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B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00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B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00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B1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00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1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soform 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X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1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soform 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X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1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soform 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X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1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soform 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X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1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soform 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X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1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soform 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X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1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soform 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X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1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soform 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X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1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soform 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X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1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soform 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X1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2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soform 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X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2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soform 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X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-lik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D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D4 isoform X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D4 isoform X2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E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B05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F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F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F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G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B0F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G_12505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B0F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G_9050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B0F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G_7515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B0F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G_10530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B0F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G5 isoform X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B0F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G5 isoform X2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B0F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H_13928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030A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H_8870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030A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H_10300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030A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H_5558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030A0"/>
                    </a:solidFill>
                  </a:tcPr>
                </a:tc>
              </a:tr>
              <a:tr h="1656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H_6864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030A0"/>
                    </a:solidFill>
                  </a:tcPr>
                </a:tc>
              </a:tr>
            </a:tbl>
          </a:graphicData>
        </a:graphic>
      </p:graphicFrame>
      <p:sp>
        <p:nvSpPr>
          <p:cNvPr id="25" name="TextBox 24"/>
          <p:cNvSpPr txBox="1"/>
          <p:nvPr/>
        </p:nvSpPr>
        <p:spPr>
          <a:xfrm>
            <a:off x="1028883" y="327533"/>
            <a:ext cx="5040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ko-KR" sz="1400" b="1" dirty="0" smtClean="0">
                <a:solidFill>
                  <a:srgbClr val="000000"/>
                </a:solidFill>
                <a:latin typeface="Times New Roman" pitchFamily="18" charset="0"/>
              </a:rPr>
              <a:t>I</a:t>
            </a:r>
            <a:endParaRPr lang="en-US" altLang="ko-KR" sz="1400" dirty="0">
              <a:latin typeface="Times New Roman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537753" y="327533"/>
            <a:ext cx="5040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ko-KR" sz="1400" b="1" dirty="0">
                <a:solidFill>
                  <a:srgbClr val="000000"/>
                </a:solidFill>
                <a:latin typeface="Times New Roman" pitchFamily="18" charset="0"/>
              </a:rPr>
              <a:t>II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2058498" y="327533"/>
            <a:ext cx="5326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I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2626743" y="327533"/>
            <a:ext cx="5040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I</a:t>
            </a:r>
            <a:r>
              <a:rPr lang="en-US" altLang="ko-KR" sz="1400" b="1" dirty="0" smtClean="0">
                <a:solidFill>
                  <a:srgbClr val="000000"/>
                </a:solidFill>
                <a:latin typeface="Times New Roman" pitchFamily="18" charset="0"/>
              </a:rPr>
              <a:t>I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3098402" y="327533"/>
            <a:ext cx="5576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ko-KR" sz="1400" b="1" dirty="0" smtClean="0">
                <a:solidFill>
                  <a:srgbClr val="000000"/>
                </a:solidFill>
                <a:latin typeface="Times New Roman" pitchFamily="18" charset="0"/>
              </a:rPr>
              <a:t>III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668233" y="327533"/>
            <a:ext cx="5326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III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4224603" y="327533"/>
            <a:ext cx="5040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4757223" y="327533"/>
            <a:ext cx="5040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7" name="Picture 4" descr="C:\Users\CBJeong\Desktop\3.jpg"/>
          <p:cNvPicPr preferRelativeResize="0">
            <a:picLocks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" t="5841" r="45886"/>
          <a:stretch/>
        </p:blipFill>
        <p:spPr bwMode="auto">
          <a:xfrm>
            <a:off x="964382" y="612084"/>
            <a:ext cx="4283280" cy="848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585106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678</TotalTime>
  <Words>177</Words>
  <Application>Microsoft Office PowerPoint</Application>
  <PresentationFormat>화면 슬라이드 쇼(4:3)</PresentationFormat>
  <Paragraphs>103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CB</dc:creator>
  <cp:lastModifiedBy>JSR</cp:lastModifiedBy>
  <cp:revision>166</cp:revision>
  <cp:lastPrinted>2013-12-05T12:01:32Z</cp:lastPrinted>
  <dcterms:created xsi:type="dcterms:W3CDTF">2013-01-14T11:02:46Z</dcterms:created>
  <dcterms:modified xsi:type="dcterms:W3CDTF">2014-07-18T07:28:53Z</dcterms:modified>
</cp:coreProperties>
</file>